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1" r:id="rId3"/>
  </p:sldIdLst>
  <p:sldSz cx="6858000" cy="9906000" type="A4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4" userDrawn="1">
          <p15:clr>
            <a:srgbClr val="A4A3A4"/>
          </p15:clr>
        </p15:guide>
        <p15:guide id="2" pos="21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842" autoAdjust="0"/>
  </p:normalViewPr>
  <p:slideViewPr>
    <p:cSldViewPr showGuides="1">
      <p:cViewPr>
        <p:scale>
          <a:sx n="75" d="100"/>
          <a:sy n="75" d="100"/>
        </p:scale>
        <p:origin x="798" y="288"/>
      </p:cViewPr>
      <p:guideLst>
        <p:guide orient="horz" pos="4984"/>
        <p:guide pos="211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F92502-F19A-4AC8-A881-167DED2B2F7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6C82C5-D46F-46C9-9516-5C33F184B3A7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emf"/><Relationship Id="rId1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对象 15"/>
          <p:cNvGraphicFramePr>
            <a:graphicFrameLocks noChangeAspect="1"/>
          </p:cNvGraphicFramePr>
          <p:nvPr/>
        </p:nvGraphicFramePr>
        <p:xfrm>
          <a:off x="995413" y="5853915"/>
          <a:ext cx="2525713" cy="16891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" name="Prism 9" r:id="rId1" imgW="2990850" imgH="2266950" progId="Prism9.Document">
                  <p:embed/>
                </p:oleObj>
              </mc:Choice>
              <mc:Fallback>
                <p:oleObj name="Prism 9" r:id="rId1" imgW="2990850" imgH="2266950" progId="Prism9.Document">
                  <p:embed/>
                  <p:pic>
                    <p:nvPicPr>
                      <p:cNvPr id="0" name="图片 5120"/>
                      <p:cNvPicPr>
                        <a:picLocks noChangeAspect="1"/>
                      </p:cNvPicPr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995413" y="5853915"/>
                        <a:ext cx="2525713" cy="1689184"/>
                      </a:xfrm>
                      <a:prstGeom prst="rect">
                        <a:avLst/>
                      </a:prstGeom>
                      <a:noFill/>
                      <a:ln w="9525"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文本框 24"/>
          <p:cNvSpPr txBox="1"/>
          <p:nvPr/>
        </p:nvSpPr>
        <p:spPr>
          <a:xfrm>
            <a:off x="1131129" y="6029674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 rot="19591614">
            <a:off x="835862" y="7515252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384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639893" y="6029674"/>
            <a:ext cx="5148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io-NC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138154" y="6221628"/>
            <a:ext cx="10166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Bio-circ_0008285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874430" y="73038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874430" y="696260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16721" y="6617501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816721" y="6279034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816721" y="5938883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16200000">
            <a:off x="-69205" y="6625056"/>
            <a:ext cx="16834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dirty="0">
                <a:latin typeface="Arial" panose="020B0604020202020204" pitchFamily="34" charset="0"/>
              </a:rPr>
              <a:t>Relative abundance  (% of input)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 rot="19591614">
            <a:off x="997715" y="7556364"/>
            <a:ext cx="721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515-3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 rot="19591614">
            <a:off x="1360677" y="7531166"/>
            <a:ext cx="6303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519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 rot="19591614">
            <a:off x="1651377" y="7531166"/>
            <a:ext cx="6303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516b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 rot="19591614">
            <a:off x="1944840" y="7531166"/>
            <a:ext cx="6303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127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9591614">
            <a:off x="2280217" y="7515252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6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 rot="19591614">
            <a:off x="2581671" y="7515252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62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 rot="19591614">
            <a:off x="2870371" y="7515252"/>
            <a:ext cx="5725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iR-647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1422889" y="7006606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1717103" y="7047575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2004488" y="7008399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2294481" y="6668854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2586157" y="6849516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164303" y="6727863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zh-CN" altLang="en-US" sz="800" kern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2873523" y="7099521"/>
            <a:ext cx="36957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zh-CN" altLang="en-US" sz="800" kern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800" kern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组合 88"/>
          <p:cNvGrpSpPr/>
          <p:nvPr/>
        </p:nvGrpSpPr>
        <p:grpSpPr>
          <a:xfrm>
            <a:off x="3978186" y="6178654"/>
            <a:ext cx="2273933" cy="1457471"/>
            <a:chOff x="690723" y="4664968"/>
            <a:chExt cx="2273933" cy="1457471"/>
          </a:xfrm>
        </p:grpSpPr>
        <p:graphicFrame>
          <p:nvGraphicFramePr>
            <p:cNvPr id="72" name="对象 71"/>
            <p:cNvGraphicFramePr>
              <a:graphicFrameLocks noChangeAspect="1"/>
            </p:cNvGraphicFramePr>
            <p:nvPr/>
          </p:nvGraphicFramePr>
          <p:xfrm>
            <a:off x="1124744" y="4664968"/>
            <a:ext cx="1839912" cy="1331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" name="Prism 8" r:id="rId3" imgW="2990850" imgH="2428875" progId="Prism9.Document">
                    <p:embed/>
                  </p:oleObj>
                </mc:Choice>
                <mc:Fallback>
                  <p:oleObj name="Prism 8" r:id="rId3" imgW="2990850" imgH="2428875" progId="Prism9.Document">
                    <p:embed/>
                    <p:pic>
                      <p:nvPicPr>
                        <p:cNvPr id="0" name="图片 5130"/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124744" y="4664968"/>
                          <a:ext cx="1839912" cy="1331912"/>
                        </a:xfrm>
                        <a:prstGeom prst="rect">
                          <a:avLst/>
                        </a:prstGeom>
                        <a:noFill/>
                        <a:ln w="9525"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8" name="文本框 77"/>
            <p:cNvSpPr txBox="1"/>
            <p:nvPr/>
          </p:nvSpPr>
          <p:spPr>
            <a:xfrm>
              <a:off x="690723" y="4907686"/>
              <a:ext cx="246221" cy="1051560"/>
            </a:xfrm>
            <a:prstGeom prst="rect">
              <a:avLst/>
            </a:prstGeom>
            <a:noFill/>
          </p:spPr>
          <p:txBody>
            <a:bodyPr vert="vert270" wrap="square" lIns="0" tIns="0" rIns="0" bIns="0" rtlCol="0" anchor="b" anchorCtr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circ_0008285 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11"/>
            <p:cNvSpPr txBox="1"/>
            <p:nvPr/>
          </p:nvSpPr>
          <p:spPr>
            <a:xfrm>
              <a:off x="1430723" y="4709253"/>
              <a:ext cx="925195" cy="12255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-NC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11"/>
            <p:cNvSpPr txBox="1"/>
            <p:nvPr/>
          </p:nvSpPr>
          <p:spPr>
            <a:xfrm>
              <a:off x="1430723" y="4852763"/>
              <a:ext cx="925195" cy="12255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800">
                  <a:latin typeface="Arial" panose="020B0604020202020204" pitchFamily="34" charset="0"/>
                  <a:cs typeface="Arial" panose="020B0604020202020204" pitchFamily="34" charset="0"/>
                </a:rPr>
                <a:t>miR-384</a:t>
              </a:r>
              <a:endParaRPr lang="en-US" altLang="zh-CN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1408495" y="5908444"/>
              <a:ext cx="454025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kern="600" dirty="0">
                  <a:latin typeface="Arial" panose="020B0604020202020204" pitchFamily="34" charset="0"/>
                  <a:cs typeface="Arial" panose="020B0604020202020204" pitchFamily="34" charset="0"/>
                </a:rPr>
                <a:t>U251</a:t>
              </a:r>
              <a:endParaRPr lang="en-US" altLang="zh-CN" sz="800" kern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2254475" y="5908444"/>
              <a:ext cx="454025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kern="600" dirty="0">
                  <a:latin typeface="Arial" panose="020B0604020202020204" pitchFamily="34" charset="0"/>
                  <a:cs typeface="Arial" panose="020B0604020202020204" pitchFamily="34" charset="0"/>
                </a:rPr>
                <a:t>U87</a:t>
              </a:r>
              <a:endParaRPr lang="en-US" altLang="zh-CN" sz="800" kern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>
              <a:off x="840537" y="5792823"/>
              <a:ext cx="379119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kern="60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altLang="zh-CN" sz="800" kern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840537" y="4785078"/>
              <a:ext cx="379119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kern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altLang="zh-CN" sz="800" kern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840537" y="5120993"/>
              <a:ext cx="379119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kern="60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altLang="zh-CN" sz="800" kern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840537" y="5456908"/>
              <a:ext cx="379119" cy="213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kern="60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altLang="zh-CN" sz="800" kern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文本框 77"/>
          <p:cNvSpPr txBox="1"/>
          <p:nvPr/>
        </p:nvSpPr>
        <p:spPr>
          <a:xfrm>
            <a:off x="0" y="47921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1"/>
          <p:cNvSpPr txBox="1"/>
          <p:nvPr/>
        </p:nvSpPr>
        <p:spPr>
          <a:xfrm>
            <a:off x="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77"/>
          <p:cNvSpPr txBox="1"/>
          <p:nvPr/>
        </p:nvSpPr>
        <p:spPr>
          <a:xfrm>
            <a:off x="326435" y="57850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77"/>
          <p:cNvSpPr txBox="1"/>
          <p:nvPr/>
        </p:nvSpPr>
        <p:spPr>
          <a:xfrm>
            <a:off x="3645451" y="57850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32" name="Picture 1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04664" y="632520"/>
            <a:ext cx="6044530" cy="38502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33" name="Picture 1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32656" y="4579895"/>
            <a:ext cx="6155209" cy="12595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7cd564b2-6056-4913-a6ae-f1cf588c171c"/>
  <p:tag name="COMMONDATA" val="eyJoZGlkIjoiYjEyMWRiYmM4MDM5OTljNTk4YWMwMWFiZmE5YjUzZWY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3</Words>
  <Application>WPS 演示</Application>
  <PresentationFormat>A4 纸张(210x297 毫米)</PresentationFormat>
  <Paragraphs>75</Paragraphs>
  <Slides>1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等线</vt:lpstr>
      <vt:lpstr>微软雅黑</vt:lpstr>
      <vt:lpstr>Office 主题</vt:lpstr>
      <vt:lpstr>Prism9.Document</vt:lpstr>
      <vt:lpstr>Prism9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蔡美娟</dc:creator>
  <cp:lastModifiedBy> 〖奋青〗</cp:lastModifiedBy>
  <cp:revision>305</cp:revision>
  <dcterms:created xsi:type="dcterms:W3CDTF">2020-08-24T10:48:00Z</dcterms:created>
  <dcterms:modified xsi:type="dcterms:W3CDTF">2023-07-18T06:52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D3A4DAE6F337491BBCA008AF099E246E</vt:lpwstr>
  </property>
</Properties>
</file>